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9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100" d="100"/>
          <a:sy n="100" d="100"/>
        </p:scale>
        <p:origin x="141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76316F18-A8F9-43F9-943D-49FCC525E503}"/>
              </a:ext>
            </a:extLst>
          </p:cNvPr>
          <p:cNvSpPr/>
          <p:nvPr/>
        </p:nvSpPr>
        <p:spPr>
          <a:xfrm>
            <a:off x="600004" y="599840"/>
            <a:ext cx="5657992" cy="5538832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60DA226-6B33-409C-81C8-E0136EBF13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05033" y="715210"/>
            <a:ext cx="4826000" cy="4122420"/>
          </a:xfrm>
          <a:prstGeom prst="rect">
            <a:avLst/>
          </a:prstGeom>
        </p:spPr>
      </p:pic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C4FA4FB8-C3CF-47B9-A5B6-4AB7492347FB}"/>
              </a:ext>
            </a:extLst>
          </p:cNvPr>
          <p:cNvGraphicFramePr>
            <a:graphicFrameLocks noGrp="1"/>
          </p:cNvGraphicFramePr>
          <p:nvPr/>
        </p:nvGraphicFramePr>
        <p:xfrm>
          <a:off x="720654" y="1220471"/>
          <a:ext cx="657416" cy="359687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57416">
                  <a:extLst>
                    <a:ext uri="{9D8B030D-6E8A-4147-A177-3AD203B41FA5}">
                      <a16:colId xmlns:a16="http://schemas.microsoft.com/office/drawing/2014/main" val="1076131507"/>
                    </a:ext>
                  </a:extLst>
                </a:gridCol>
              </a:tblGrid>
              <a:tr h="70088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5Del/1Ins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0658263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5Del/1Ins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9364584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3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8083192"/>
                  </a:ext>
                </a:extLst>
              </a:tr>
              <a:tr h="135889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5Del/6In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5378840"/>
                  </a:ext>
                </a:extLst>
              </a:tr>
              <a:tr h="110727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4Del/4In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971276"/>
                  </a:ext>
                </a:extLst>
              </a:tr>
              <a:tr h="88901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6Del/4In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3503617"/>
                  </a:ext>
                </a:extLst>
              </a:tr>
              <a:tr h="134384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3Del/1Ins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7809388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5Del/1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1651241"/>
                  </a:ext>
                </a:extLst>
              </a:tr>
              <a:tr h="120649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6Del/2Ins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1964434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5Del/4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6836669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2Del/3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707336"/>
                  </a:ext>
                </a:extLst>
              </a:tr>
              <a:tr h="11961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5Del/1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5853756"/>
                  </a:ext>
                </a:extLst>
              </a:tr>
              <a:tr h="120412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6Del/2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2672060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Del/3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9519607"/>
                  </a:ext>
                </a:extLst>
              </a:tr>
              <a:tr h="131842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5Del/1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2812820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4Del/1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3828310"/>
                  </a:ext>
                </a:extLst>
              </a:tr>
              <a:tr h="12342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2Del/4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6040352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6Del/1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4505055"/>
                  </a:ext>
                </a:extLst>
              </a:tr>
              <a:tr h="11049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4202305"/>
                  </a:ext>
                </a:extLst>
              </a:tr>
              <a:tr h="11811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Del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0005399"/>
                  </a:ext>
                </a:extLst>
              </a:tr>
              <a:tr h="11811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Del/3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2916659"/>
                  </a:ext>
                </a:extLst>
              </a:tr>
              <a:tr h="10668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2Del/3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6615911"/>
                  </a:ext>
                </a:extLst>
              </a:tr>
              <a:tr h="9675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8Del/8In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9376280"/>
                  </a:ext>
                </a:extLst>
              </a:tr>
              <a:tr h="14097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Del/3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3263437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5Del/10In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1948592"/>
                  </a:ext>
                </a:extLst>
              </a:tr>
              <a:tr h="12954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3Del/1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0529590"/>
                  </a:ext>
                </a:extLst>
              </a:tr>
              <a:tr h="12954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0Del/7In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82165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Del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53849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5618787"/>
                  </a:ext>
                </a:extLst>
              </a:tr>
              <a:tr h="7008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Del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7840702"/>
                  </a:ext>
                </a:extLst>
              </a:tr>
              <a:tr h="115808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5Del/1Ins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82565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B107C6F-FD19-4CB6-8C44-592E9D0DD7F8}"/>
              </a:ext>
            </a:extLst>
          </p:cNvPr>
          <p:cNvSpPr txBox="1"/>
          <p:nvPr/>
        </p:nvSpPr>
        <p:spPr>
          <a:xfrm>
            <a:off x="600004" y="6327194"/>
            <a:ext cx="565799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Low"/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Supplementary Figure 5 | Genotyping of targeted </a:t>
            </a:r>
            <a:r>
              <a:rPr lang="en-US" sz="1000" b="1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XRCC4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 using pggCtMR (</a:t>
            </a:r>
            <a:r>
              <a:rPr lang="en-US" sz="1000" b="1" dirty="0" err="1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ExV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).</a:t>
            </a:r>
            <a:r>
              <a:rPr lang="en-US" sz="1000" dirty="0">
                <a:highlight>
                  <a:srgbClr val="FFFF00"/>
                </a:highlight>
              </a:rPr>
              <a:t> 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a</a:t>
            </a:r>
            <a:r>
              <a:rPr lang="en-US" sz="1000" dirty="0">
                <a:highlight>
                  <a:srgbClr val="FFFF00"/>
                </a:highlight>
              </a:rPr>
              <a:t>, On-target genotyping of </a:t>
            </a:r>
            <a:r>
              <a:rPr lang="en-US" sz="1000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XRCC4</a:t>
            </a:r>
            <a:r>
              <a:rPr lang="en-US" sz="1000" dirty="0">
                <a:highlight>
                  <a:srgbClr val="FFFF00"/>
                </a:highlight>
              </a:rPr>
              <a:t> happened by pggCtMR through </a:t>
            </a:r>
            <a:r>
              <a:rPr lang="en-US" sz="1000" dirty="0" err="1">
                <a:highlight>
                  <a:srgbClr val="FFFF00"/>
                </a:highlight>
              </a:rPr>
              <a:t>ExV</a:t>
            </a:r>
            <a:r>
              <a:rPr lang="en-US" sz="1000" dirty="0">
                <a:highlight>
                  <a:srgbClr val="FFFF00"/>
                </a:highlight>
              </a:rPr>
              <a:t> events comparing with WT as the reference. Highlights present disagreements concerning exhibit insertions (Ins), deletions (Del), and SNPs (S). 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b</a:t>
            </a:r>
            <a:r>
              <a:rPr lang="en-US" sz="1000" dirty="0">
                <a:highlight>
                  <a:srgbClr val="FFFF00"/>
                </a:highlight>
              </a:rPr>
              <a:t>, Off-target genotyping of </a:t>
            </a:r>
            <a:r>
              <a:rPr lang="en-US" sz="1000" i="1" dirty="0">
                <a:highlight>
                  <a:srgbClr val="FFFF00"/>
                </a:highlight>
              </a:rPr>
              <a:t>XRCC4</a:t>
            </a:r>
            <a:r>
              <a:rPr lang="en-US" sz="1000" dirty="0">
                <a:highlight>
                  <a:srgbClr val="FFFF00"/>
                </a:highlight>
              </a:rPr>
              <a:t> happened through </a:t>
            </a:r>
            <a:r>
              <a:rPr lang="en-US" sz="1000" dirty="0" err="1">
                <a:highlight>
                  <a:srgbClr val="FFFF00"/>
                </a:highlight>
              </a:rPr>
              <a:t>ExV</a:t>
            </a:r>
            <a:r>
              <a:rPr lang="en-US" sz="1000" dirty="0">
                <a:highlight>
                  <a:srgbClr val="FFFF00"/>
                </a:highlight>
              </a:rPr>
              <a:t> events compared with WT as the reference through Locus NC_037298.1 (Chr. LGXIV) located on intragenic regions : 3,741,796 -&gt;3,741,818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53E5D2E-4C82-45BF-9529-B6BDA0AA8828}"/>
              </a:ext>
            </a:extLst>
          </p:cNvPr>
          <p:cNvSpPr txBox="1"/>
          <p:nvPr/>
        </p:nvSpPr>
        <p:spPr>
          <a:xfrm>
            <a:off x="713224" y="654257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F5B79D9-C81C-449C-BA94-0198177FE6A9}"/>
              </a:ext>
            </a:extLst>
          </p:cNvPr>
          <p:cNvSpPr txBox="1"/>
          <p:nvPr/>
        </p:nvSpPr>
        <p:spPr>
          <a:xfrm>
            <a:off x="709264" y="4952674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EEC855E-99DB-4ACD-8E83-70FE04BBF81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colorTemperature colorTemp="11200"/>
                    </a14:imgEffect>
                  </a14:imgLayer>
                </a14:imgProps>
              </a:ext>
            </a:extLst>
          </a:blip>
          <a:srcRect r="5407"/>
          <a:stretch/>
        </p:blipFill>
        <p:spPr>
          <a:xfrm>
            <a:off x="2094342" y="5220063"/>
            <a:ext cx="2669312" cy="545199"/>
          </a:xfrm>
          <a:prstGeom prst="rect">
            <a:avLst/>
          </a:prstGeom>
          <a:noFill/>
          <a:ln w="6350">
            <a:noFill/>
          </a:ln>
        </p:spPr>
      </p:pic>
    </p:spTree>
    <p:extLst>
      <p:ext uri="{BB962C8B-B14F-4D97-AF65-F5344CB8AC3E}">
        <p14:creationId xmlns:p14="http://schemas.microsoft.com/office/powerpoint/2010/main" val="1407344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00</Words>
  <Application>Microsoft Office PowerPoint</Application>
  <PresentationFormat>A4 Paper (210x297 mm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9</cp:revision>
  <dcterms:created xsi:type="dcterms:W3CDTF">2022-05-10T05:11:22Z</dcterms:created>
  <dcterms:modified xsi:type="dcterms:W3CDTF">2022-05-16T05:42:26Z</dcterms:modified>
</cp:coreProperties>
</file>